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</p:sldIdLst>
  <p:sldSz cx="7772400" cy="10058400"/>
  <p:notesSz cx="7019925" cy="93059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70" d="100"/>
          <a:sy n="70" d="100"/>
        </p:scale>
        <p:origin x="-2016" y="-128"/>
      </p:cViewPr>
      <p:guideLst>
        <p:guide orient="horz" pos="3168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90454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12102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11104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14727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54955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5579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42077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35767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24847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49464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81181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6BA309-EED0-4E3D-952F-D980B7D41BD7}" type="datetimeFigureOut">
              <a:rPr lang="en-US" smtClean="0"/>
              <a:pPr/>
              <a:t>5/28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0EC217-65B5-4623-A499-DD6E58D726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94983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668161" y="5733534"/>
            <a:ext cx="537519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aplan-Meier curves </a:t>
            </a:r>
            <a:r>
              <a:rPr lang="en-US" sz="1200" dirty="0" smtClean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comparing PFS in patients with and without vascular invasion of their tumor.  Log-rank test demonstrated no significant association between PFS and vascular invasion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2"/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1668160" y="1869769"/>
            <a:ext cx="4905635" cy="38637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599118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446</TotalTime>
  <Words>35</Words>
  <Application>Microsoft Macintosh PowerPoint</Application>
  <PresentationFormat>Custom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tg55</dc:creator>
  <cp:lastModifiedBy>Ryan T</cp:lastModifiedBy>
  <cp:revision>23</cp:revision>
  <cp:lastPrinted>2015-04-23T21:25:43Z</cp:lastPrinted>
  <dcterms:created xsi:type="dcterms:W3CDTF">2015-04-23T20:59:46Z</dcterms:created>
  <dcterms:modified xsi:type="dcterms:W3CDTF">2015-05-29T02:12:35Z</dcterms:modified>
</cp:coreProperties>
</file>